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4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CDKN1B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1jsu_C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1jsu_C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2910" y="193843"/>
            <a:ext cx="2611460" cy="28779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57818" y="214290"/>
            <a:ext cx="2786082" cy="306469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42910" y="3214686"/>
            <a:ext cx="2643206" cy="2714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357818" y="3357562"/>
            <a:ext cx="2857520" cy="264320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8</cp:revision>
  <dcterms:created xsi:type="dcterms:W3CDTF">2018-05-10T07:33:24Z</dcterms:created>
  <dcterms:modified xsi:type="dcterms:W3CDTF">2018-05-29T06:54:48Z</dcterms:modified>
</cp:coreProperties>
</file>